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44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0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628266" y="326542"/>
            <a:ext cx="6062972" cy="5283683"/>
            <a:chOff x="2190116" y="421792"/>
            <a:chExt cx="6062972" cy="5283683"/>
          </a:xfrm>
        </p:grpSpPr>
        <p:pic>
          <p:nvPicPr>
            <p:cNvPr id="10" name="그림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52" t="18577" r="5063" b="-598"/>
            <a:stretch/>
          </p:blipFill>
          <p:spPr bwMode="auto">
            <a:xfrm>
              <a:off x="3457576" y="1247775"/>
              <a:ext cx="4381500" cy="44577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0" name="TextBox 431"/>
            <p:cNvSpPr txBox="1"/>
            <p:nvPr/>
          </p:nvSpPr>
          <p:spPr>
            <a:xfrm>
              <a:off x="2404133" y="1305618"/>
              <a:ext cx="1112419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p-FLT3</a:t>
              </a:r>
              <a:r>
                <a:rPr lang="en-US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Y589/Y591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433"/>
            <p:cNvSpPr txBox="1"/>
            <p:nvPr/>
          </p:nvSpPr>
          <p:spPr>
            <a:xfrm>
              <a:off x="2762110" y="1581996"/>
              <a:ext cx="732089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FLT3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433"/>
            <p:cNvSpPr txBox="1"/>
            <p:nvPr/>
          </p:nvSpPr>
          <p:spPr>
            <a:xfrm>
              <a:off x="2762110" y="1855938"/>
              <a:ext cx="732089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FLT3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433"/>
            <p:cNvSpPr txBox="1"/>
            <p:nvPr/>
          </p:nvSpPr>
          <p:spPr>
            <a:xfrm>
              <a:off x="7785808" y="1600884"/>
              <a:ext cx="467280" cy="2539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S.E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433"/>
            <p:cNvSpPr txBox="1"/>
            <p:nvPr/>
          </p:nvSpPr>
          <p:spPr>
            <a:xfrm>
              <a:off x="7810686" y="1877253"/>
              <a:ext cx="441666" cy="2539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dirty="0">
                  <a:solidFill>
                    <a:srgbClr val="000000"/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L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.E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435"/>
            <p:cNvSpPr txBox="1"/>
            <p:nvPr/>
          </p:nvSpPr>
          <p:spPr>
            <a:xfrm>
              <a:off x="2450666" y="2239919"/>
              <a:ext cx="1067973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p-SYK</a:t>
              </a:r>
              <a:r>
                <a:rPr lang="en-US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Y525/526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439"/>
            <p:cNvSpPr txBox="1"/>
            <p:nvPr/>
          </p:nvSpPr>
          <p:spPr>
            <a:xfrm>
              <a:off x="2760319" y="2515807"/>
              <a:ext cx="732089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SYK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437"/>
            <p:cNvSpPr txBox="1"/>
            <p:nvPr/>
          </p:nvSpPr>
          <p:spPr>
            <a:xfrm>
              <a:off x="2926373" y="3147348"/>
              <a:ext cx="566034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JAK1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437"/>
            <p:cNvSpPr txBox="1"/>
            <p:nvPr/>
          </p:nvSpPr>
          <p:spPr>
            <a:xfrm>
              <a:off x="2190116" y="3484247"/>
              <a:ext cx="1311254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dirty="0">
                  <a:solidFill>
                    <a:srgbClr val="000000"/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p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-JAK2</a:t>
              </a:r>
              <a:r>
                <a:rPr lang="en-US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Y1007/1008</a:t>
              </a:r>
              <a:endParaRPr lang="en-US" sz="120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437"/>
            <p:cNvSpPr txBox="1"/>
            <p:nvPr/>
          </p:nvSpPr>
          <p:spPr>
            <a:xfrm>
              <a:off x="2945423" y="3779301"/>
              <a:ext cx="547232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JAK2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446"/>
            <p:cNvSpPr txBox="1"/>
            <p:nvPr/>
          </p:nvSpPr>
          <p:spPr>
            <a:xfrm>
              <a:off x="2426587" y="4122031"/>
              <a:ext cx="1067973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p-STAT5</a:t>
              </a:r>
              <a:r>
                <a:rPr lang="en-US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Y694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448"/>
            <p:cNvSpPr txBox="1"/>
            <p:nvPr/>
          </p:nvSpPr>
          <p:spPr>
            <a:xfrm>
              <a:off x="2840648" y="4398282"/>
              <a:ext cx="642235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STAT5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442"/>
            <p:cNvSpPr txBox="1"/>
            <p:nvPr/>
          </p:nvSpPr>
          <p:spPr>
            <a:xfrm>
              <a:off x="2478656" y="4733966"/>
              <a:ext cx="1061624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p-STAT3</a:t>
              </a:r>
              <a:r>
                <a:rPr lang="en-US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Y705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444"/>
            <p:cNvSpPr txBox="1"/>
            <p:nvPr/>
          </p:nvSpPr>
          <p:spPr>
            <a:xfrm>
              <a:off x="2878748" y="5013005"/>
              <a:ext cx="604206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STAT3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477"/>
            <p:cNvSpPr txBox="1"/>
            <p:nvPr/>
          </p:nvSpPr>
          <p:spPr>
            <a:xfrm>
              <a:off x="2760319" y="5368653"/>
              <a:ext cx="737471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GAPDH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413"/>
            <p:cNvSpPr txBox="1"/>
            <p:nvPr/>
          </p:nvSpPr>
          <p:spPr>
            <a:xfrm rot="16200000">
              <a:off x="3238426" y="842277"/>
              <a:ext cx="782319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MOLM-14</a:t>
              </a:r>
              <a:endParaRPr lang="en-US" sz="105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414"/>
            <p:cNvSpPr txBox="1"/>
            <p:nvPr/>
          </p:nvSpPr>
          <p:spPr>
            <a:xfrm>
              <a:off x="3884407" y="1043377"/>
              <a:ext cx="2262488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0</a:t>
              </a:r>
              <a:r>
                <a:rPr lang="en-US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      10      30      100    300    1000</a:t>
              </a:r>
              <a:endParaRPr lang="en-US" sz="10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414"/>
            <p:cNvSpPr txBox="1"/>
            <p:nvPr/>
          </p:nvSpPr>
          <p:spPr>
            <a:xfrm>
              <a:off x="5906903" y="1039123"/>
              <a:ext cx="1977224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10      30      100    300    1000</a:t>
              </a:r>
              <a:endParaRPr lang="en-US" sz="105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직선 연결선 855"/>
            <p:cNvCxnSpPr/>
            <p:nvPr/>
          </p:nvCxnSpPr>
          <p:spPr>
            <a:xfrm>
              <a:off x="4201837" y="1024123"/>
              <a:ext cx="164592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30" name="TextBox 427"/>
            <p:cNvSpPr txBox="1"/>
            <p:nvPr/>
          </p:nvSpPr>
          <p:spPr>
            <a:xfrm>
              <a:off x="4438773" y="749030"/>
              <a:ext cx="1077497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ct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Tuspetinib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직선 연결선 857"/>
            <p:cNvCxnSpPr/>
            <p:nvPr/>
          </p:nvCxnSpPr>
          <p:spPr>
            <a:xfrm>
              <a:off x="6025485" y="1024123"/>
              <a:ext cx="164592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32" name="TextBox 429"/>
            <p:cNvSpPr txBox="1"/>
            <p:nvPr/>
          </p:nvSpPr>
          <p:spPr>
            <a:xfrm>
              <a:off x="6180818" y="746319"/>
              <a:ext cx="1077497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ct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Gilteritinib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430"/>
            <p:cNvSpPr txBox="1"/>
            <p:nvPr/>
          </p:nvSpPr>
          <p:spPr>
            <a:xfrm>
              <a:off x="7697470" y="1034426"/>
              <a:ext cx="49885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 (nM)</a:t>
              </a:r>
              <a:endParaRPr lang="en-US" sz="105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직선 연결선 855"/>
            <p:cNvCxnSpPr>
              <a:cxnSpLocks/>
            </p:cNvCxnSpPr>
            <p:nvPr/>
          </p:nvCxnSpPr>
          <p:spPr>
            <a:xfrm>
              <a:off x="3884407" y="713257"/>
              <a:ext cx="3794207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35" name="TextBox 427"/>
            <p:cNvSpPr txBox="1"/>
            <p:nvPr/>
          </p:nvSpPr>
          <p:spPr>
            <a:xfrm>
              <a:off x="5015621" y="421792"/>
              <a:ext cx="1244060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ct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HS-5 co-culture</a:t>
              </a:r>
              <a:endPara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437"/>
            <p:cNvSpPr txBox="1"/>
            <p:nvPr/>
          </p:nvSpPr>
          <p:spPr>
            <a:xfrm>
              <a:off x="2313530" y="2864796"/>
              <a:ext cx="1184929" cy="25391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algn="r" latinLnBrk="1">
                <a:spcBef>
                  <a:spcPts val="0"/>
                </a:spcBef>
                <a:spcAft>
                  <a:spcPts val="0"/>
                </a:spcAft>
              </a:pPr>
              <a:r>
                <a:rPr lang="en-US" sz="1050" dirty="0">
                  <a:solidFill>
                    <a:srgbClr val="000000"/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p</a:t>
              </a: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-JAK1 </a:t>
              </a:r>
              <a:r>
                <a:rPr lang="en-US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Y1034/1035</a:t>
              </a:r>
              <a:endParaRPr lang="en-US" sz="120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281047" y="5751448"/>
            <a:ext cx="11610858" cy="7671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Western blot analysis of the effect of co-culture with HS-5 cells on the ability of TUS and gilteritinib to reduce the ratio of phosphorylated to total levels of FLT3 and downstream kinases SYK, JAK1, JAK2, STAT3 and STAT5. A representative Western blot from 2 independent experiments is shown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5558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39</TotalTime>
  <Words>100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19</cp:revision>
  <cp:lastPrinted>2024-09-20T16:49:30Z</cp:lastPrinted>
  <dcterms:created xsi:type="dcterms:W3CDTF">2023-07-11T20:23:00Z</dcterms:created>
  <dcterms:modified xsi:type="dcterms:W3CDTF">2024-11-11T03:10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